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249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60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8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54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149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84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53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87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30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36A162-316E-3AED-3721-02469A052C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5320" y="3906837"/>
            <a:ext cx="10515600" cy="2219643"/>
          </a:xfrm>
        </p:spPr>
        <p:txBody>
          <a:bodyPr>
            <a:no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3.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wo examples of transcutaneous excision of typical upper eyelid WGDCs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.</a:t>
            </a:r>
            <a:br>
              <a:rPr lang="en-US" sz="36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,B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 48-year-old woman having right upper eyelid medial WGDC with mechanical ptosis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,D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ostoperative appearance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,F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 65-year-old man having right upper eyelid medial WGDC with mechanical ptosis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,H </a:t>
            </a:r>
            <a:r>
              <a:rPr lang="en-US" sz="1400" b="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ostoperation</a:t>
            </a:r>
            <a:r>
              <a:rPr lang="en-US" sz="14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br>
              <a:rPr lang="en-US" sz="36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 descr="A collage of a person's eyes&#10;&#10;Description automatically generated">
            <a:extLst>
              <a:ext uri="{FF2B5EF4-FFF2-40B4-BE49-F238E27FC236}">
                <a16:creationId xmlns:a16="http://schemas.microsoft.com/office/drawing/2014/main" id="{5F50DACD-83B6-EA7A-2FF6-4D095A44EBD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320" y="191546"/>
            <a:ext cx="10515600" cy="2925575"/>
          </a:xfrm>
        </p:spPr>
      </p:pic>
    </p:spTree>
    <p:extLst>
      <p:ext uri="{BB962C8B-B14F-4D97-AF65-F5344CB8AC3E}">
        <p14:creationId xmlns:p14="http://schemas.microsoft.com/office/powerpoint/2010/main" val="3037650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 3.Two examples of transcutaneous excision of typical upper eyelid WGDCs . A,B A 48-year-old woman having right upper eyelid medial WGDC with mechanical ptosis. C,D Postoperative appearance. E,F A 65-year-old man having right upper eyelid medial WGDC with mechanical ptosis. G,H Postoperation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mosta</dc:creator>
  <cp:lastModifiedBy>Mahmoud Mohamed Diab</cp:lastModifiedBy>
  <cp:revision>1</cp:revision>
  <dcterms:created xsi:type="dcterms:W3CDTF">2023-12-18T04:59:55Z</dcterms:created>
  <dcterms:modified xsi:type="dcterms:W3CDTF">2023-12-18T05:02:04Z</dcterms:modified>
</cp:coreProperties>
</file>